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94"/>
  </p:normalViewPr>
  <p:slideViewPr>
    <p:cSldViewPr snapToGrid="0" snapToObjects="1">
      <p:cViewPr varScale="1">
        <p:scale>
          <a:sx n="85" d="100"/>
          <a:sy n="85" d="100"/>
        </p:scale>
        <p:origin x="102" y="3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27DE2-DB16-6D47-BE9A-E773CE0E30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CC9D8E-D8F9-954A-914E-F1498042F9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64AE2C-DB47-784B-9B92-CFDEC8BEA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3EA086-443D-C045-936D-4146F229E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15EC0-4E31-DA4E-AB45-6D9F2F755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318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D55D29-7620-9442-8F4D-E3D1F1135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F818E1-AB14-4E43-8F27-3AAC438DDB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D500BA-7458-F946-BB56-F58F4A1D1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BC9F83-5876-BE40-AC39-173B47995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AF67D4-F05D-9F4D-B4ED-90F8179FF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097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DAC48C-85D6-A743-8630-17BA937E4D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904370-F140-B240-B35F-556A776181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2C634-7AA3-CD41-94AF-60A1C87D0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AA9F2-2447-604E-88AF-4B939010D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DF2EF2-26DE-3C45-8FA0-BED25E90B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53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D8C47-44C4-AF40-87CF-1CB6B3B73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C7D65-9496-F74B-8FEF-6DEBD7823C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42F37D-E2E6-F24E-A70F-A3D4B647A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411FE5-E2F4-E548-8D57-CE5C4CA76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D32E67-B0DC-674B-A9B6-7E8AF1E59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304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DAF29-F2E2-1D42-99B2-7868FEE6B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426678-39C4-AE44-8320-2B1F52334D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791EA0-86BB-0B44-904C-35609E143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BDE37-932D-6F44-9F2B-4277DB2D0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651804-1EC2-B445-A44E-79AFE4339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739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1D582-E72F-3B45-AD26-023A8DA23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C640C1-D8F5-A049-8C4C-D7A7BF9778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F288B9-5E66-5741-8C73-4D316CD633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E04A38-CF59-4B45-AC47-969972AE5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269D8B-5793-E74D-A2D0-88357A2CC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C26180-0E0A-C24B-BF08-E217CD045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232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108F83-AF9A-7447-A53F-C798AF0A8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C7EAD5-D857-D345-8349-3E8ED8FE48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EC18BC-79E5-BF4A-B179-73C58CF1E4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78AC38-A6DA-9B47-93AE-E4B6859ABC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A2C28F-B920-5C4D-A810-EE5548CB94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F691DB-9269-044D-80F8-F0F96F188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2DC709-1787-B14A-B689-8B7DA8C5D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0B7C92-B68F-F743-B385-24F6D9855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022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734CB-6EEA-254F-AFD4-2DC4D99DAE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776F4D-B1F0-994D-BD8D-B24AFDBE0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CCD26E-3EB3-BE4C-A819-D334DA377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E60354-ADD1-E94D-87D8-E72FC18A0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30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A2A80F-705B-314E-AA16-B9B16697D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51B19A-DAED-A04D-B72B-156C95F62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E9304E-C7FD-D54A-ADF2-2BCE71AA4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281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3C74A-1AA6-B44A-A5FF-64154B5DC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D97BAE-5556-F44B-A210-05CD9883DF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0E2088-FB2C-6B48-8030-A40AAACE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700CA0-0AA0-654F-A4AB-72267B17A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FF78B6-8CE9-B548-9262-1C7AFEBB2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8A8E99-B9C5-0C46-A2C9-D22B59C90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828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517526-456F-A746-BE6A-7E75671FB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93BCAC-BD78-7546-BBB7-55A115FBAD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3061C3-BC8E-C245-8534-3C98C49A95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97E667-DF22-C44F-B331-0884390B1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9468B9-846C-9E4F-B9CC-FD9D70ABC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7A57CD-35DF-FF48-99FD-B1EF17938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027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8AF500-205F-DA4A-839B-9F719C2626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B9FC47-D673-6D4A-AB17-C0B59ACABC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DF2BE-2E1D-1047-B444-6C082E19BC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096239-11CE-4643-BC49-16BE878176E4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AB571-7AAE-CA4D-86D2-195630DCDE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A6C815-B746-724E-BAC5-BEA851A405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700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22288" y="6132644"/>
            <a:ext cx="11923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3</a:t>
            </a:r>
            <a:r>
              <a:rPr lang="en-US" dirty="0" smtClean="0"/>
              <a:t>. Amplification and melt curves for A)</a:t>
            </a:r>
            <a:r>
              <a:rPr lang="en-US" i="1" dirty="0" smtClean="0"/>
              <a:t> PsBRC1 </a:t>
            </a:r>
            <a:r>
              <a:rPr lang="en-US" dirty="0" smtClean="0"/>
              <a:t>and B) </a:t>
            </a:r>
            <a:r>
              <a:rPr lang="en-US" i="1" dirty="0" smtClean="0"/>
              <a:t>PsDRM1 </a:t>
            </a:r>
            <a:r>
              <a:rPr lang="en-US" dirty="0" smtClean="0"/>
              <a:t>in pea buds of control group. (n=4)</a:t>
            </a:r>
            <a:endParaRPr lang="en-AU" i="1" dirty="0"/>
          </a:p>
        </p:txBody>
      </p:sp>
      <p:sp>
        <p:nvSpPr>
          <p:cNvPr id="5" name="TextBox 4"/>
          <p:cNvSpPr txBox="1"/>
          <p:nvPr/>
        </p:nvSpPr>
        <p:spPr>
          <a:xfrm>
            <a:off x="181551" y="23617"/>
            <a:ext cx="4133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 smtClean="0"/>
              <a:t>A</a:t>
            </a:r>
            <a:endParaRPr lang="en-AU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579730" y="-15389"/>
            <a:ext cx="4133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 smtClean="0"/>
              <a:t>B</a:t>
            </a:r>
            <a:endParaRPr lang="en-AU" sz="20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181" y="307486"/>
            <a:ext cx="4657725" cy="288607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86158" y="251041"/>
            <a:ext cx="4657725" cy="2886075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4533" y="3046514"/>
            <a:ext cx="4638675" cy="288607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8231" y="3174044"/>
            <a:ext cx="4638675" cy="288607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614310" y="134920"/>
            <a:ext cx="2167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 smtClean="0"/>
              <a:t>P</a:t>
            </a:r>
            <a:r>
              <a:rPr lang="en-US" altLang="zh-CN" i="1" dirty="0" smtClean="0"/>
              <a:t>sBRC1</a:t>
            </a:r>
            <a:endParaRPr lang="en-AU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7031287" y="100015"/>
            <a:ext cx="2167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 smtClean="0"/>
              <a:t>P</a:t>
            </a:r>
            <a:r>
              <a:rPr lang="en-US" altLang="zh-CN" i="1" dirty="0" smtClean="0"/>
              <a:t>sDRM1</a:t>
            </a:r>
            <a:endParaRPr lang="en-AU" i="1" dirty="0"/>
          </a:p>
        </p:txBody>
      </p:sp>
    </p:spTree>
    <p:extLst>
      <p:ext uri="{BB962C8B-B14F-4D97-AF65-F5344CB8AC3E}">
        <p14:creationId xmlns:p14="http://schemas.microsoft.com/office/powerpoint/2010/main" val="2842138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3</TotalTime>
  <Words>3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 Cao</dc:creator>
  <cp:lastModifiedBy>Da Cao</cp:lastModifiedBy>
  <cp:revision>20</cp:revision>
  <dcterms:created xsi:type="dcterms:W3CDTF">2020-04-04T08:00:48Z</dcterms:created>
  <dcterms:modified xsi:type="dcterms:W3CDTF">2020-07-29T07:33:43Z</dcterms:modified>
</cp:coreProperties>
</file>